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8A03E58-AEDE-4B77-89E1-7C2C4C787B9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F9458A9-C4B1-4A73-8BA2-3F8FA73965F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44E5D16-9AE6-4AC0-8CDB-312129B137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0EAA3-51BB-4574-B391-5CB4EE97DC45}" type="datetimeFigureOut">
              <a:rPr lang="zh-CN" altLang="en-US" smtClean="0"/>
              <a:t>2022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DC31588-75B6-48D9-BA0F-50109F28AD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8DC81E8-A5A0-44A9-9351-AA5FD7215C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05592E-D0AA-4F75-AE86-7FD2690E13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94081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8207B67-670C-4F0C-BF58-BD7FE10BCC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EBB9458-EB60-48BB-9668-0CA4365DC4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3C69E11-4672-437D-A4B1-8DE04D8B63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0EAA3-51BB-4574-B391-5CB4EE97DC45}" type="datetimeFigureOut">
              <a:rPr lang="zh-CN" altLang="en-US" smtClean="0"/>
              <a:t>2022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AEE6EE4-ECBE-4DB4-A615-3310EC40A7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B2557AC-0C9E-4416-9810-527C7A4B51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05592E-D0AA-4F75-AE86-7FD2690E13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78763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E507013B-FFC1-4F1D-A79D-E4A18FB5030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04E2DAD-07D1-426D-BD41-D4926948FF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D788D38-32FE-4996-B772-859009F2FE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0EAA3-51BB-4574-B391-5CB4EE97DC45}" type="datetimeFigureOut">
              <a:rPr lang="zh-CN" altLang="en-US" smtClean="0"/>
              <a:t>2022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80A0FB3-B2FE-449D-9A8D-148DEB0495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1875AD2-A8DA-42B6-92A5-C1E3520FF4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05592E-D0AA-4F75-AE86-7FD2690E13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14457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8FBDF25-0EE6-4D9E-BA23-812401C631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A0C61C4-D12B-4E68-B693-D77F0040FA8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1460D38-8C6E-44DA-BEFA-516BAA1DF3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0EAA3-51BB-4574-B391-5CB4EE97DC45}" type="datetimeFigureOut">
              <a:rPr lang="zh-CN" altLang="en-US" smtClean="0"/>
              <a:t>2022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ECD7475-01FA-482F-BD76-22B77EBA55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08D0456-5A23-4F88-9C50-7FB2091C47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05592E-D0AA-4F75-AE86-7FD2690E13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44544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E79C0A6-D73E-4B90-9153-320F67A4D3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9616E04-4E1E-4BED-9AE8-30856C4363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9530EE-6D3F-4191-BB7C-F68B221C33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0EAA3-51BB-4574-B391-5CB4EE97DC45}" type="datetimeFigureOut">
              <a:rPr lang="zh-CN" altLang="en-US" smtClean="0"/>
              <a:t>2022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84611E6-B815-4F7C-A02A-A4288DD513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D026A83-32C5-4497-96DE-AF8DFC00F7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05592E-D0AA-4F75-AE86-7FD2690E13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08441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30D6150-29F7-4367-B989-47923F696F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3203044-C1C2-4EC7-9E3F-113A35D6ACB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7629F1F-BA22-49DC-A8CC-26CEEC50D2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2C5D423-F5FD-4C06-B351-9B60F01F98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0EAA3-51BB-4574-B391-5CB4EE97DC45}" type="datetimeFigureOut">
              <a:rPr lang="zh-CN" altLang="en-US" smtClean="0"/>
              <a:t>2022/1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F6BEFD4-B979-4C33-8F9D-6A7205961E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F1C7B78-D4D3-4D4A-B200-3B794BF9AD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05592E-D0AA-4F75-AE86-7FD2690E13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44592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C94F05A-6837-4E64-9199-ACC8985EDF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0FEBC9C-06CC-47B6-BD9E-358935B45D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18577A6-0EF4-4EF4-9F23-16506C822A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3372A5D3-BC29-4850-A148-98791F5CFEB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ECD13C8-70C9-4B82-A81C-5D6F40A4B71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4F922EB9-DB33-4D7B-BBAD-3C8695124D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0EAA3-51BB-4574-B391-5CB4EE97DC45}" type="datetimeFigureOut">
              <a:rPr lang="zh-CN" altLang="en-US" smtClean="0"/>
              <a:t>2022/1/2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A27AD41-58E5-4BF8-AD2F-C953CA7E66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2CCCE63F-7746-40FA-B4CD-48FA0D38FE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05592E-D0AA-4F75-AE86-7FD2690E13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08372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2FC825B-7F06-49BF-8029-784A1A6112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3D850F5-9E19-4C52-9F5A-2D0CE13149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0EAA3-51BB-4574-B391-5CB4EE97DC45}" type="datetimeFigureOut">
              <a:rPr lang="zh-CN" altLang="en-US" smtClean="0"/>
              <a:t>2022/1/2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43989773-C3A5-462F-8AC6-8C15E5FFB4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C2D0665-2211-4988-8C4B-D103137C2F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05592E-D0AA-4F75-AE86-7FD2690E13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72482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E4955E2-3256-4033-AC0D-8E3CF45E9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0EAA3-51BB-4574-B391-5CB4EE97DC45}" type="datetimeFigureOut">
              <a:rPr lang="zh-CN" altLang="en-US" smtClean="0"/>
              <a:t>2022/1/2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3282DA80-5359-43A5-A435-0D5735574B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DD8C914-5AC1-472E-A97F-C06AB7A261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05592E-D0AA-4F75-AE86-7FD2690E13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71966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FB67380-70CE-4C9C-9479-8F5C4F8895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62BAF1E-6C29-4FD1-9762-7BAC6AE55EB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B74E1E8-EF89-4AD3-886D-83419036A7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7343F67-946A-4FC7-8010-B14F0A44C4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0EAA3-51BB-4574-B391-5CB4EE97DC45}" type="datetimeFigureOut">
              <a:rPr lang="zh-CN" altLang="en-US" smtClean="0"/>
              <a:t>2022/1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80B6B02-0742-4CE2-9A87-EBEC13A4E1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6DBB36A-822E-48D9-AA1F-3707BB105A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05592E-D0AA-4F75-AE86-7FD2690E13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74392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E8DFACD-7AF1-45E9-AC23-906829BA51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7B7D51FB-1BD2-4EC9-BB4A-73AB443F9C5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173400D-BB06-4842-9425-09A18D2FE64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050A742-0765-42B6-B638-351DE13E58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0EAA3-51BB-4574-B391-5CB4EE97DC45}" type="datetimeFigureOut">
              <a:rPr lang="zh-CN" altLang="en-US" smtClean="0"/>
              <a:t>2022/1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DE7C65B-C4D4-4A24-B335-EF21BE6DCC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82F31F4-E8C0-4F00-B9D1-F0A9DEA2BA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05592E-D0AA-4F75-AE86-7FD2690E13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2886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1F642BF-EEAF-4097-A866-A3E0502B6B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EC2B3BE-0B2C-4A95-BCCA-A825FCF9C2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9C8DAA1-0E1F-4D69-A626-6DB5634CE6C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60EAA3-51BB-4574-B391-5CB4EE97DC45}" type="datetimeFigureOut">
              <a:rPr lang="zh-CN" altLang="en-US" smtClean="0"/>
              <a:t>2022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56464EB-76C1-44F3-A30A-5BA9CBF8A52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598BEC7-6238-4E7E-A921-9BCD5D4B77B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05592E-D0AA-4F75-AE86-7FD2690E13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65154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11" Type="http://schemas.openxmlformats.org/officeDocument/2006/relationships/image" Target="../media/image18.png"/><Relationship Id="rId5" Type="http://schemas.openxmlformats.org/officeDocument/2006/relationships/image" Target="../media/image12.png"/><Relationship Id="rId10" Type="http://schemas.openxmlformats.org/officeDocument/2006/relationships/image" Target="../media/image17.tif"/><Relationship Id="rId4" Type="http://schemas.openxmlformats.org/officeDocument/2006/relationships/image" Target="../media/image11.png"/><Relationship Id="rId9" Type="http://schemas.openxmlformats.org/officeDocument/2006/relationships/image" Target="../media/image16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Relationship Id="rId9" Type="http://schemas.openxmlformats.org/officeDocument/2006/relationships/image" Target="../media/image2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296718" y="298911"/>
            <a:ext cx="11205055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Figure 3D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(Marker-Thermo Scientific #26616; pAKT1-CST #5012; AKT1-CST #2938; </a:t>
            </a:r>
          </a:p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pAKT2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-CST #8599;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AKT2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-CST #3063;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GAPDH-Proteintech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#60004-1-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1g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411" t="32453" r="38929" b="18739"/>
          <a:stretch/>
        </p:blipFill>
        <p:spPr>
          <a:xfrm>
            <a:off x="624251" y="3661192"/>
            <a:ext cx="1793632" cy="2910254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633" t="32748" r="38485" b="19034"/>
          <a:stretch/>
        </p:blipFill>
        <p:spPr>
          <a:xfrm>
            <a:off x="668213" y="1054843"/>
            <a:ext cx="1659111" cy="2523393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914400" y="3991708"/>
            <a:ext cx="1072662" cy="184638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矩形 10"/>
          <p:cNvSpPr/>
          <p:nvPr/>
        </p:nvSpPr>
        <p:spPr>
          <a:xfrm>
            <a:off x="931984" y="5024000"/>
            <a:ext cx="1072662" cy="184638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矩形 11"/>
          <p:cNvSpPr/>
          <p:nvPr/>
        </p:nvSpPr>
        <p:spPr>
          <a:xfrm>
            <a:off x="940776" y="5815307"/>
            <a:ext cx="1072662" cy="184638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文本框 12"/>
          <p:cNvSpPr txBox="1"/>
          <p:nvPr/>
        </p:nvSpPr>
        <p:spPr>
          <a:xfrm>
            <a:off x="2083777" y="3930138"/>
            <a:ext cx="12485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D3-PDGFR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2083777" y="4962430"/>
            <a:ext cx="12485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D3-AKT2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2083777" y="5753737"/>
            <a:ext cx="12485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D3-GAPDH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2327324" y="1233577"/>
            <a:ext cx="6418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2327323" y="1427081"/>
            <a:ext cx="6418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2327322" y="1734798"/>
            <a:ext cx="6418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2387113" y="1991239"/>
            <a:ext cx="6418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2387112" y="2188831"/>
            <a:ext cx="6418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2373681" y="2543734"/>
            <a:ext cx="6418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2384872" y="2892556"/>
            <a:ext cx="6418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2373681" y="954376"/>
            <a:ext cx="7822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图片 25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299" t="39236" r="41040" b="24195"/>
          <a:stretch/>
        </p:blipFill>
        <p:spPr>
          <a:xfrm>
            <a:off x="8773019" y="3781705"/>
            <a:ext cx="1898808" cy="2660477"/>
          </a:xfrm>
          <a:prstGeom prst="rect">
            <a:avLst/>
          </a:prstGeom>
        </p:spPr>
      </p:pic>
      <p:pic>
        <p:nvPicPr>
          <p:cNvPr id="27" name="图片 26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633" t="38646" r="40928" b="24638"/>
          <a:stretch/>
        </p:blipFill>
        <p:spPr>
          <a:xfrm>
            <a:off x="8773019" y="938446"/>
            <a:ext cx="1776532" cy="2527752"/>
          </a:xfrm>
          <a:prstGeom prst="rect">
            <a:avLst/>
          </a:prstGeom>
        </p:spPr>
      </p:pic>
      <p:sp>
        <p:nvSpPr>
          <p:cNvPr id="28" name="矩形 27"/>
          <p:cNvSpPr/>
          <p:nvPr/>
        </p:nvSpPr>
        <p:spPr>
          <a:xfrm>
            <a:off x="8992486" y="4773416"/>
            <a:ext cx="1430216" cy="229427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文本框 28"/>
          <p:cNvSpPr txBox="1"/>
          <p:nvPr/>
        </p:nvSpPr>
        <p:spPr>
          <a:xfrm>
            <a:off x="10496476" y="4728214"/>
            <a:ext cx="12485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D3-pAKT2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图片 29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966" t="43512" r="39262" b="17855"/>
          <a:stretch/>
        </p:blipFill>
        <p:spPr>
          <a:xfrm>
            <a:off x="6637425" y="3991708"/>
            <a:ext cx="1802423" cy="2303585"/>
          </a:xfrm>
          <a:prstGeom prst="rect">
            <a:avLst/>
          </a:prstGeom>
        </p:spPr>
      </p:pic>
      <p:pic>
        <p:nvPicPr>
          <p:cNvPr id="31" name="图片 30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745" t="43217" r="39927" b="18739"/>
          <a:stretch/>
        </p:blipFill>
        <p:spPr>
          <a:xfrm>
            <a:off x="6454429" y="1013069"/>
            <a:ext cx="1927956" cy="2474690"/>
          </a:xfrm>
          <a:prstGeom prst="rect">
            <a:avLst/>
          </a:prstGeom>
        </p:spPr>
      </p:pic>
      <p:sp>
        <p:nvSpPr>
          <p:cNvPr id="32" name="矩形 31"/>
          <p:cNvSpPr/>
          <p:nvPr/>
        </p:nvSpPr>
        <p:spPr>
          <a:xfrm>
            <a:off x="6922832" y="4882517"/>
            <a:ext cx="1227637" cy="229427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文本框 32"/>
          <p:cNvSpPr txBox="1"/>
          <p:nvPr/>
        </p:nvSpPr>
        <p:spPr>
          <a:xfrm>
            <a:off x="6970596" y="4476654"/>
            <a:ext cx="12485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D3-AKT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" name="图片 33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411" t="36729" r="39818" b="27734"/>
          <a:stretch/>
        </p:blipFill>
        <p:spPr>
          <a:xfrm>
            <a:off x="3710519" y="3995321"/>
            <a:ext cx="2042299" cy="2299972"/>
          </a:xfrm>
          <a:prstGeom prst="rect">
            <a:avLst/>
          </a:prstGeom>
        </p:spPr>
      </p:pic>
      <p:pic>
        <p:nvPicPr>
          <p:cNvPr id="35" name="图片 34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077" t="36139" r="40262" b="27440"/>
          <a:stretch/>
        </p:blipFill>
        <p:spPr>
          <a:xfrm>
            <a:off x="3658591" y="1054843"/>
            <a:ext cx="1903703" cy="2411355"/>
          </a:xfrm>
          <a:prstGeom prst="rect">
            <a:avLst/>
          </a:prstGeom>
        </p:spPr>
      </p:pic>
      <p:sp>
        <p:nvSpPr>
          <p:cNvPr id="36" name="矩形 35"/>
          <p:cNvSpPr/>
          <p:nvPr/>
        </p:nvSpPr>
        <p:spPr>
          <a:xfrm>
            <a:off x="4219648" y="4921277"/>
            <a:ext cx="1342646" cy="287361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文本框 36"/>
          <p:cNvSpPr txBox="1"/>
          <p:nvPr/>
        </p:nvSpPr>
        <p:spPr>
          <a:xfrm>
            <a:off x="5506795" y="4940644"/>
            <a:ext cx="12485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D3-pAKT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17997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858" t="36877" r="32043" b="11956"/>
          <a:stretch/>
        </p:blipFill>
        <p:spPr>
          <a:xfrm>
            <a:off x="58473" y="3364486"/>
            <a:ext cx="2971800" cy="2720881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747" t="37171" r="32264" b="11808"/>
          <a:stretch/>
        </p:blipFill>
        <p:spPr>
          <a:xfrm>
            <a:off x="142000" y="700464"/>
            <a:ext cx="2804746" cy="2567307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454128" y="3997765"/>
            <a:ext cx="1072662" cy="184638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矩形 5"/>
          <p:cNvSpPr/>
          <p:nvPr/>
        </p:nvSpPr>
        <p:spPr>
          <a:xfrm>
            <a:off x="454128" y="4815682"/>
            <a:ext cx="1072662" cy="30669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6"/>
          <p:cNvSpPr txBox="1"/>
          <p:nvPr/>
        </p:nvSpPr>
        <p:spPr>
          <a:xfrm>
            <a:off x="369134" y="3676695"/>
            <a:ext cx="12485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D6-PDGFR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454128" y="5148961"/>
            <a:ext cx="12485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D6-AKT2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矩形 8"/>
          <p:cNvSpPr/>
          <p:nvPr/>
        </p:nvSpPr>
        <p:spPr>
          <a:xfrm>
            <a:off x="1553167" y="3997765"/>
            <a:ext cx="1072662" cy="184638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矩形 9"/>
          <p:cNvSpPr/>
          <p:nvPr/>
        </p:nvSpPr>
        <p:spPr>
          <a:xfrm>
            <a:off x="1617644" y="4827191"/>
            <a:ext cx="1072662" cy="30669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/>
          <p:cNvSpPr txBox="1"/>
          <p:nvPr/>
        </p:nvSpPr>
        <p:spPr>
          <a:xfrm>
            <a:off x="1553900" y="5147960"/>
            <a:ext cx="12485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D9-AKT2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1556832" y="3676694"/>
            <a:ext cx="12485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D9-PDGFR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2900389" y="1160504"/>
            <a:ext cx="6418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2900388" y="1354008"/>
            <a:ext cx="6418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2900387" y="1617765"/>
            <a:ext cx="6418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2960178" y="1830242"/>
            <a:ext cx="6418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2960177" y="2045418"/>
            <a:ext cx="6418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2946746" y="2391533"/>
            <a:ext cx="6418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2957937" y="2713975"/>
            <a:ext cx="6418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2946746" y="881303"/>
            <a:ext cx="7822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图片 28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299" t="35992" r="42262" b="25964"/>
          <a:stretch/>
        </p:blipFill>
        <p:spPr>
          <a:xfrm>
            <a:off x="7854631" y="3830582"/>
            <a:ext cx="1566334" cy="2434423"/>
          </a:xfrm>
          <a:prstGeom prst="rect">
            <a:avLst/>
          </a:prstGeom>
        </p:spPr>
      </p:pic>
      <p:pic>
        <p:nvPicPr>
          <p:cNvPr id="30" name="图片 29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632" t="35254" r="42039" b="26112"/>
          <a:stretch/>
        </p:blipFill>
        <p:spPr>
          <a:xfrm>
            <a:off x="8000407" y="751045"/>
            <a:ext cx="1308342" cy="2077489"/>
          </a:xfrm>
          <a:prstGeom prst="rect">
            <a:avLst/>
          </a:prstGeom>
        </p:spPr>
      </p:pic>
      <p:sp>
        <p:nvSpPr>
          <p:cNvPr id="31" name="矩形 30"/>
          <p:cNvSpPr/>
          <p:nvPr/>
        </p:nvSpPr>
        <p:spPr>
          <a:xfrm>
            <a:off x="8082518" y="4738832"/>
            <a:ext cx="1178753" cy="266847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" name="文本框 31"/>
          <p:cNvSpPr txBox="1"/>
          <p:nvPr/>
        </p:nvSpPr>
        <p:spPr>
          <a:xfrm>
            <a:off x="9223579" y="4765414"/>
            <a:ext cx="15213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D6-pAKT2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图片 32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077" t="37024" r="40484" b="21394"/>
          <a:stretch/>
        </p:blipFill>
        <p:spPr>
          <a:xfrm>
            <a:off x="5913928" y="3905649"/>
            <a:ext cx="1365285" cy="2200059"/>
          </a:xfrm>
          <a:prstGeom prst="rect">
            <a:avLst/>
          </a:prstGeom>
        </p:spPr>
      </p:pic>
      <p:pic>
        <p:nvPicPr>
          <p:cNvPr id="34" name="图片 33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744" t="39678" r="40706" b="21689"/>
          <a:stretch/>
        </p:blipFill>
        <p:spPr>
          <a:xfrm>
            <a:off x="5874580" y="751044"/>
            <a:ext cx="1395564" cy="2077489"/>
          </a:xfrm>
          <a:prstGeom prst="rect">
            <a:avLst/>
          </a:prstGeom>
        </p:spPr>
      </p:pic>
      <p:sp>
        <p:nvSpPr>
          <p:cNvPr id="35" name="矩形 34"/>
          <p:cNvSpPr/>
          <p:nvPr/>
        </p:nvSpPr>
        <p:spPr>
          <a:xfrm>
            <a:off x="6047359" y="4780947"/>
            <a:ext cx="1027888" cy="266847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6" name="文本框 35"/>
          <p:cNvSpPr txBox="1"/>
          <p:nvPr/>
        </p:nvSpPr>
        <p:spPr>
          <a:xfrm>
            <a:off x="6145093" y="4392978"/>
            <a:ext cx="9981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D6-AKT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" name="图片 36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744" t="38351" r="42927" b="24637"/>
          <a:stretch/>
        </p:blipFill>
        <p:spPr>
          <a:xfrm>
            <a:off x="10421726" y="3925588"/>
            <a:ext cx="1386984" cy="2109897"/>
          </a:xfrm>
          <a:prstGeom prst="rect">
            <a:avLst/>
          </a:prstGeom>
        </p:spPr>
      </p:pic>
      <p:pic>
        <p:nvPicPr>
          <p:cNvPr id="38" name="图片 37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855" t="38793" r="43706" b="24195"/>
          <a:stretch/>
        </p:blipFill>
        <p:spPr>
          <a:xfrm>
            <a:off x="10424701" y="773988"/>
            <a:ext cx="1357333" cy="2170003"/>
          </a:xfrm>
          <a:prstGeom prst="rect">
            <a:avLst/>
          </a:prstGeom>
        </p:spPr>
      </p:pic>
      <p:sp>
        <p:nvSpPr>
          <p:cNvPr id="39" name="矩形 38"/>
          <p:cNvSpPr/>
          <p:nvPr/>
        </p:nvSpPr>
        <p:spPr>
          <a:xfrm>
            <a:off x="10510426" y="4962496"/>
            <a:ext cx="971104" cy="20222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0" name="文本框 39"/>
          <p:cNvSpPr txBox="1"/>
          <p:nvPr/>
        </p:nvSpPr>
        <p:spPr>
          <a:xfrm>
            <a:off x="10510426" y="5232459"/>
            <a:ext cx="13328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D6-GAPDH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" name="图片 40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31367" y="3893186"/>
            <a:ext cx="1583748" cy="2174699"/>
          </a:xfrm>
          <a:prstGeom prst="rect">
            <a:avLst/>
          </a:prstGeom>
        </p:spPr>
      </p:pic>
      <p:pic>
        <p:nvPicPr>
          <p:cNvPr id="42" name="图片 41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188" t="31715" r="38041" b="25375"/>
          <a:stretch/>
        </p:blipFill>
        <p:spPr>
          <a:xfrm>
            <a:off x="3792587" y="773988"/>
            <a:ext cx="1464174" cy="2078413"/>
          </a:xfrm>
          <a:prstGeom prst="rect">
            <a:avLst/>
          </a:prstGeom>
        </p:spPr>
      </p:pic>
      <p:sp>
        <p:nvSpPr>
          <p:cNvPr id="43" name="矩形 42"/>
          <p:cNvSpPr/>
          <p:nvPr/>
        </p:nvSpPr>
        <p:spPr>
          <a:xfrm>
            <a:off x="3934997" y="4890876"/>
            <a:ext cx="1027888" cy="266847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4" name="文本框 43"/>
          <p:cNvSpPr txBox="1"/>
          <p:nvPr/>
        </p:nvSpPr>
        <p:spPr>
          <a:xfrm>
            <a:off x="3966306" y="4546866"/>
            <a:ext cx="11300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D6-pAKT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956907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图片 2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82" t="42037" r="28154" b="19477"/>
          <a:stretch/>
        </p:blipFill>
        <p:spPr>
          <a:xfrm>
            <a:off x="3244058" y="3673494"/>
            <a:ext cx="3716233" cy="2041973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860" t="41595" r="28710" b="19624"/>
          <a:stretch/>
        </p:blipFill>
        <p:spPr>
          <a:xfrm>
            <a:off x="3431826" y="1222608"/>
            <a:ext cx="3528465" cy="1966073"/>
          </a:xfrm>
          <a:prstGeom prst="rect">
            <a:avLst/>
          </a:prstGeom>
        </p:spPr>
      </p:pic>
      <p:sp>
        <p:nvSpPr>
          <p:cNvPr id="25" name="矩形 24"/>
          <p:cNvSpPr/>
          <p:nvPr/>
        </p:nvSpPr>
        <p:spPr>
          <a:xfrm>
            <a:off x="5553860" y="4247618"/>
            <a:ext cx="1022786" cy="27290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文本框 25"/>
          <p:cNvSpPr txBox="1"/>
          <p:nvPr/>
        </p:nvSpPr>
        <p:spPr>
          <a:xfrm>
            <a:off x="5627798" y="3939841"/>
            <a:ext cx="11109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D9-AKT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图片 26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523" t="43954" r="40706" b="13578"/>
          <a:stretch/>
        </p:blipFill>
        <p:spPr>
          <a:xfrm>
            <a:off x="7263084" y="3939841"/>
            <a:ext cx="1573785" cy="1953665"/>
          </a:xfrm>
          <a:prstGeom prst="rect">
            <a:avLst/>
          </a:prstGeom>
        </p:spPr>
      </p:pic>
      <p:pic>
        <p:nvPicPr>
          <p:cNvPr id="28" name="图片 27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967" t="44691" r="42817" b="13725"/>
          <a:stretch/>
        </p:blipFill>
        <p:spPr>
          <a:xfrm>
            <a:off x="7273261" y="987272"/>
            <a:ext cx="1564729" cy="2206269"/>
          </a:xfrm>
          <a:prstGeom prst="rect">
            <a:avLst/>
          </a:prstGeom>
        </p:spPr>
      </p:pic>
      <p:sp>
        <p:nvSpPr>
          <p:cNvPr id="29" name="矩形 28"/>
          <p:cNvSpPr/>
          <p:nvPr/>
        </p:nvSpPr>
        <p:spPr>
          <a:xfrm>
            <a:off x="7537256" y="4674000"/>
            <a:ext cx="954485" cy="27290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文本框 29"/>
          <p:cNvSpPr txBox="1"/>
          <p:nvPr/>
        </p:nvSpPr>
        <p:spPr>
          <a:xfrm>
            <a:off x="7537256" y="4342539"/>
            <a:ext cx="11109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D9-pAKT2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图片 30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301" t="37024" r="44927" b="19771"/>
          <a:stretch/>
        </p:blipFill>
        <p:spPr>
          <a:xfrm>
            <a:off x="9153937" y="3872570"/>
            <a:ext cx="1603848" cy="2292329"/>
          </a:xfrm>
          <a:prstGeom prst="rect">
            <a:avLst/>
          </a:prstGeom>
        </p:spPr>
      </p:pic>
      <p:pic>
        <p:nvPicPr>
          <p:cNvPr id="32" name="图片 31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190" t="36581" r="44705" b="19919"/>
          <a:stretch/>
        </p:blipFill>
        <p:spPr>
          <a:xfrm>
            <a:off x="9153936" y="968826"/>
            <a:ext cx="1556907" cy="2307978"/>
          </a:xfrm>
          <a:prstGeom prst="rect">
            <a:avLst/>
          </a:prstGeom>
        </p:spPr>
      </p:pic>
      <p:sp>
        <p:nvSpPr>
          <p:cNvPr id="33" name="矩形 32"/>
          <p:cNvSpPr/>
          <p:nvPr/>
        </p:nvSpPr>
        <p:spPr>
          <a:xfrm>
            <a:off x="9306335" y="5327837"/>
            <a:ext cx="1221919" cy="27290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" name="文本框 33"/>
          <p:cNvSpPr txBox="1"/>
          <p:nvPr/>
        </p:nvSpPr>
        <p:spPr>
          <a:xfrm>
            <a:off x="9417293" y="5001710"/>
            <a:ext cx="11109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D9-GAPDH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2674062" y="1540960"/>
            <a:ext cx="6418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2674061" y="1699296"/>
            <a:ext cx="6418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2674060" y="1883920"/>
            <a:ext cx="6418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2733851" y="2061231"/>
            <a:ext cx="6418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2733850" y="2302781"/>
            <a:ext cx="6418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2731610" y="2477432"/>
            <a:ext cx="6418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2720419" y="1261759"/>
            <a:ext cx="7822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81B120E8-B862-453E-8E66-BF4B2A8EE055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49" t="34679" r="24951" b="36271"/>
          <a:stretch/>
        </p:blipFill>
        <p:spPr>
          <a:xfrm>
            <a:off x="66534" y="3914831"/>
            <a:ext cx="3101325" cy="1399373"/>
          </a:xfrm>
          <a:prstGeom prst="rect">
            <a:avLst/>
          </a:prstGeom>
        </p:spPr>
      </p:pic>
      <p:sp>
        <p:nvSpPr>
          <p:cNvPr id="37" name="矩形 36"/>
          <p:cNvSpPr/>
          <p:nvPr/>
        </p:nvSpPr>
        <p:spPr>
          <a:xfrm>
            <a:off x="1617196" y="4544422"/>
            <a:ext cx="1041060" cy="297658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8" name="文本框 37"/>
          <p:cNvSpPr txBox="1"/>
          <p:nvPr/>
        </p:nvSpPr>
        <p:spPr>
          <a:xfrm>
            <a:off x="1547295" y="4236645"/>
            <a:ext cx="11109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D9-pAKT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251C8E02-F1DC-47E0-9ACD-CF45207A4A61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59" t="25397" r="26891" b="35896"/>
          <a:stretch/>
        </p:blipFill>
        <p:spPr>
          <a:xfrm>
            <a:off x="152787" y="1324626"/>
            <a:ext cx="2538355" cy="15764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410649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3</Words>
  <Application>Microsoft Office PowerPoint</Application>
  <PresentationFormat>宽屏</PresentationFormat>
  <Paragraphs>43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7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YC</dc:creator>
  <cp:lastModifiedBy>LYC</cp:lastModifiedBy>
  <cp:revision>1</cp:revision>
  <dcterms:created xsi:type="dcterms:W3CDTF">2022-01-22T03:02:09Z</dcterms:created>
  <dcterms:modified xsi:type="dcterms:W3CDTF">2022-01-22T03:02:35Z</dcterms:modified>
</cp:coreProperties>
</file>